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56" r:id="rId2"/>
    <p:sldId id="257" r:id="rId3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200" d="100"/>
          <a:sy n="200" d="100"/>
        </p:scale>
        <p:origin x="-624" y="-8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notesMaster" Target="notesMasters/notesMaster1.xml"/><Relationship Id="rId5" Type="http://schemas.openxmlformats.org/officeDocument/2006/relationships/printerSettings" Target="printerSettings/printerSettings1.bin"/><Relationship Id="rId6" Type="http://schemas.openxmlformats.org/officeDocument/2006/relationships/presProps" Target="presProps.xml"/><Relationship Id="rId7" Type="http://schemas.openxmlformats.org/officeDocument/2006/relationships/viewProps" Target="viewProps.xml"/><Relationship Id="rId8" Type="http://schemas.openxmlformats.org/officeDocument/2006/relationships/theme" Target="theme/theme1.xml"/><Relationship Id="rId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786FB07-4BA1-4B9E-92DC-A04FD623358A}" type="datetimeFigureOut">
              <a:rPr lang="en-US" smtClean="0"/>
              <a:t>3/26/1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3608F0F-4CF9-4E8E-A42B-AA6F8BDAD5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855907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2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3608F0F-4CF9-4E8E-A42B-AA6F8BDAD58F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914016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02D0E6-332A-4E29-A556-19531F217F3B}" type="datetimeFigureOut">
              <a:rPr lang="en-US" smtClean="0"/>
              <a:t>3/26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55BBE5-FB04-4888-A066-482390E69F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72810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02D0E6-332A-4E29-A556-19531F217F3B}" type="datetimeFigureOut">
              <a:rPr lang="en-US" smtClean="0"/>
              <a:t>3/26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55BBE5-FB04-4888-A066-482390E69F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51228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02D0E6-332A-4E29-A556-19531F217F3B}" type="datetimeFigureOut">
              <a:rPr lang="en-US" smtClean="0"/>
              <a:t>3/26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55BBE5-FB04-4888-A066-482390E69F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1841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02D0E6-332A-4E29-A556-19531F217F3B}" type="datetimeFigureOut">
              <a:rPr lang="en-US" smtClean="0"/>
              <a:t>3/26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55BBE5-FB04-4888-A066-482390E69F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70639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02D0E6-332A-4E29-A556-19531F217F3B}" type="datetimeFigureOut">
              <a:rPr lang="en-US" smtClean="0"/>
              <a:t>3/26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55BBE5-FB04-4888-A066-482390E69F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60602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02D0E6-332A-4E29-A556-19531F217F3B}" type="datetimeFigureOut">
              <a:rPr lang="en-US" smtClean="0"/>
              <a:t>3/26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55BBE5-FB04-4888-A066-482390E69F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31807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02D0E6-332A-4E29-A556-19531F217F3B}" type="datetimeFigureOut">
              <a:rPr lang="en-US" smtClean="0"/>
              <a:t>3/26/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55BBE5-FB04-4888-A066-482390E69F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09827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02D0E6-332A-4E29-A556-19531F217F3B}" type="datetimeFigureOut">
              <a:rPr lang="en-US" smtClean="0"/>
              <a:t>3/26/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55BBE5-FB04-4888-A066-482390E69F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05529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02D0E6-332A-4E29-A556-19531F217F3B}" type="datetimeFigureOut">
              <a:rPr lang="en-US" smtClean="0"/>
              <a:t>3/26/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55BBE5-FB04-4888-A066-482390E69F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64443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02D0E6-332A-4E29-A556-19531F217F3B}" type="datetimeFigureOut">
              <a:rPr lang="en-US" smtClean="0"/>
              <a:t>3/26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55BBE5-FB04-4888-A066-482390E69F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79888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02D0E6-332A-4E29-A556-19531F217F3B}" type="datetimeFigureOut">
              <a:rPr lang="en-US" smtClean="0"/>
              <a:t>3/26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55BBE5-FB04-4888-A066-482390E69F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60541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02D0E6-332A-4E29-A556-19531F217F3B}" type="datetimeFigureOut">
              <a:rPr lang="en-US" smtClean="0"/>
              <a:t>3/26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55BBE5-FB04-4888-A066-482390E69F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98683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Relationship Id="rId3" Type="http://schemas.openxmlformats.org/officeDocument/2006/relationships/image" Target="../media/image2.tif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685800" y="685800"/>
            <a:ext cx="5334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itchFamily="34" charset="0"/>
                <a:cs typeface="Arial" pitchFamily="34" charset="0"/>
              </a:rPr>
              <a:t>Supplementary Figure 1. 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Heat map using Ingenuity Analysis</a:t>
            </a:r>
          </a:p>
          <a:p>
            <a:r>
              <a:rPr lang="en-US" sz="1200" dirty="0">
                <a:latin typeface="Arial" pitchFamily="34" charset="0"/>
                <a:cs typeface="Arial" pitchFamily="34" charset="0"/>
              </a:rPr>
              <a:t>s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oftware and the “Cell Signaling” category. The range of difference</a:t>
            </a:r>
          </a:p>
          <a:p>
            <a:r>
              <a:rPr lang="en-US" sz="1200" dirty="0">
                <a:latin typeface="Arial" pitchFamily="34" charset="0"/>
                <a:cs typeface="Arial" pitchFamily="34" charset="0"/>
              </a:rPr>
              <a:t>b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etween DU145 and DU145LN4 groups are 1.8-16.4 fold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.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/>
          <a:srcRect t="9020" b="18435"/>
          <a:stretch/>
        </p:blipFill>
        <p:spPr>
          <a:xfrm>
            <a:off x="2286000" y="2590800"/>
            <a:ext cx="1925217" cy="3989295"/>
          </a:xfrm>
          <a:prstGeom prst="rect">
            <a:avLst/>
          </a:prstGeom>
        </p:spPr>
      </p:pic>
      <p:grpSp>
        <p:nvGrpSpPr>
          <p:cNvPr id="6" name="Group 5"/>
          <p:cNvGrpSpPr/>
          <p:nvPr/>
        </p:nvGrpSpPr>
        <p:grpSpPr>
          <a:xfrm>
            <a:off x="2565396" y="6324600"/>
            <a:ext cx="692239" cy="311112"/>
            <a:chOff x="1155878" y="1156076"/>
            <a:chExt cx="692239" cy="311112"/>
          </a:xfrm>
        </p:grpSpPr>
        <p:pic>
          <p:nvPicPr>
            <p:cNvPr id="7" name="Picture 6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44911" y="1295400"/>
              <a:ext cx="524010" cy="45719"/>
            </a:xfrm>
            <a:prstGeom prst="rect">
              <a:avLst/>
            </a:prstGeom>
          </p:spPr>
        </p:pic>
        <p:sp>
          <p:nvSpPr>
            <p:cNvPr id="8" name="TextBox 7"/>
            <p:cNvSpPr txBox="1"/>
            <p:nvPr/>
          </p:nvSpPr>
          <p:spPr>
            <a:xfrm>
              <a:off x="1278850" y="1156076"/>
              <a:ext cx="52052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 smtClean="0"/>
                <a:t>relative</a:t>
              </a:r>
              <a:endParaRPr lang="en-US" sz="600" dirty="0"/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1155878" y="1282522"/>
              <a:ext cx="30970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smtClean="0"/>
                <a:t>min</a:t>
              </a:r>
              <a:endParaRPr lang="en-US" sz="600" dirty="0"/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1517577" y="1282522"/>
              <a:ext cx="33054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smtClean="0"/>
                <a:t>max</a:t>
              </a:r>
              <a:endParaRPr lang="en-US" sz="600" dirty="0"/>
            </a:p>
          </p:txBody>
        </p:sp>
      </p:grpSp>
    </p:spTree>
    <p:extLst>
      <p:ext uri="{BB962C8B-B14F-4D97-AF65-F5344CB8AC3E}">
        <p14:creationId xmlns:p14="http://schemas.microsoft.com/office/powerpoint/2010/main" val="414605781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609600" y="914400"/>
            <a:ext cx="525780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Arial" pitchFamily="34" charset="0"/>
                <a:cs typeface="Arial" pitchFamily="34" charset="0"/>
              </a:rPr>
              <a:t>Supplementary Table 1. Relative expression levels of PLAU, EPCAM, ITGB4 and housekeeping genes in the metastatic DU145-LN </a:t>
            </a:r>
            <a:r>
              <a:rPr lang="en-US" sz="1200" b="1" dirty="0" err="1">
                <a:latin typeface="Arial" pitchFamily="34" charset="0"/>
                <a:cs typeface="Arial" pitchFamily="34" charset="0"/>
              </a:rPr>
              <a:t>sublines</a:t>
            </a:r>
            <a:r>
              <a:rPr lang="en-US" sz="1200" b="1" dirty="0">
                <a:latin typeface="Arial" pitchFamily="34" charset="0"/>
                <a:cs typeface="Arial" pitchFamily="34" charset="0"/>
              </a:rPr>
              <a:t>.</a:t>
            </a:r>
          </a:p>
        </p:txBody>
      </p:sp>
      <p:graphicFrame>
        <p:nvGraphicFramePr>
          <p:cNvPr id="6" name="Table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87899298"/>
              </p:ext>
            </p:extLst>
          </p:nvPr>
        </p:nvGraphicFramePr>
        <p:xfrm>
          <a:off x="533400" y="1905000"/>
          <a:ext cx="5638800" cy="2540000"/>
        </p:xfrm>
        <a:graphic>
          <a:graphicData uri="http://schemas.openxmlformats.org/drawingml/2006/table">
            <a:tbl>
              <a:tblPr firstRow="1" firstCol="1" lastRow="1" lastCol="1" bandRow="1" bandCol="1"/>
              <a:tblGrid>
                <a:gridCol w="752787"/>
                <a:gridCol w="1498924"/>
                <a:gridCol w="838200"/>
                <a:gridCol w="685800"/>
                <a:gridCol w="609600"/>
                <a:gridCol w="609600"/>
                <a:gridCol w="643889"/>
              </a:tblGrid>
              <a:tr h="0">
                <a:tc rowSpan="2"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Times New Roman"/>
                        </a:rPr>
                        <a:t> </a:t>
                      </a:r>
                      <a:endParaRPr lang="en-US" sz="1200" dirty="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Times New Roman"/>
                        </a:rPr>
                        <a:t> </a:t>
                      </a:r>
                      <a:endParaRPr lang="en-US" sz="1200">
                        <a:effectLst/>
                        <a:latin typeface="Times New Roman"/>
                        <a:ea typeface="Times New Roman"/>
                      </a:endParaRPr>
                    </a:p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Times New Roman"/>
                        </a:rPr>
                        <a:t>Protein</a:t>
                      </a:r>
                      <a:endParaRPr lang="en-US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Arial"/>
                          <a:ea typeface="Times New Roman"/>
                        </a:rPr>
                        <a:t> </a:t>
                      </a:r>
                      <a:endParaRPr lang="en-US" sz="1200">
                        <a:effectLst/>
                        <a:latin typeface="Times New Roman"/>
                        <a:ea typeface="Times New Roman"/>
                      </a:endParaRPr>
                    </a:p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Arial"/>
                          <a:ea typeface="Times New Roman"/>
                        </a:rPr>
                        <a:t>Gene name</a:t>
                      </a:r>
                      <a:endParaRPr lang="en-US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4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Times New Roman"/>
                        </a:rPr>
                        <a:t>Cell line</a:t>
                      </a:r>
                      <a:endParaRPr lang="en-US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  <a:latin typeface="Arial"/>
                          <a:ea typeface="Times New Roman"/>
                        </a:rPr>
                        <a:t>DU145</a:t>
                      </a:r>
                      <a:endParaRPr lang="en-US" sz="1200" dirty="0">
                        <a:effectLst/>
                        <a:latin typeface="Times New Roman"/>
                        <a:ea typeface="Times New Roman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  <a:latin typeface="Arial"/>
                          <a:ea typeface="Times New Roman"/>
                        </a:rPr>
                        <a:t>parental</a:t>
                      </a:r>
                      <a:endParaRPr lang="en-US" sz="1200" dirty="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Arial"/>
                          <a:ea typeface="Times New Roman"/>
                        </a:rPr>
                        <a:t>DU145-</a:t>
                      </a:r>
                      <a:endParaRPr lang="en-US" sz="1200">
                        <a:effectLst/>
                        <a:latin typeface="Times New Roman"/>
                        <a:ea typeface="Times New Roman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Arial"/>
                          <a:ea typeface="Times New Roman"/>
                        </a:rPr>
                        <a:t>LN1</a:t>
                      </a:r>
                      <a:endParaRPr lang="en-US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Arial"/>
                          <a:ea typeface="Times New Roman"/>
                        </a:rPr>
                        <a:t>DU145-</a:t>
                      </a:r>
                      <a:endParaRPr lang="en-US" sz="1200">
                        <a:effectLst/>
                        <a:latin typeface="Times New Roman"/>
                        <a:ea typeface="Times New Roman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Arial"/>
                          <a:ea typeface="Times New Roman"/>
                        </a:rPr>
                        <a:t>LN2</a:t>
                      </a:r>
                      <a:endParaRPr lang="en-US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Arial"/>
                          <a:ea typeface="Times New Roman"/>
                        </a:rPr>
                        <a:t>DU145-</a:t>
                      </a:r>
                      <a:endParaRPr lang="en-US" sz="1200">
                        <a:effectLst/>
                        <a:latin typeface="Times New Roman"/>
                        <a:ea typeface="Times New Roman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Arial"/>
                          <a:ea typeface="Times New Roman"/>
                        </a:rPr>
                        <a:t>LN4</a:t>
                      </a:r>
                      <a:endParaRPr lang="en-US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96545">
                <a:tc rowSpan="3">
                  <a:txBody>
                    <a:bodyPr/>
                    <a:lstStyle/>
                    <a:p>
                      <a:pPr marL="71755" marR="71755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Times New Roman"/>
                        </a:rPr>
                        <a:t>Cell movement and invasion genes</a:t>
                      </a:r>
                      <a:endParaRPr lang="en-US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 vert="vert27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Times New Roman"/>
                        </a:rPr>
                        <a:t>uPA</a:t>
                      </a:r>
                      <a:endParaRPr lang="en-US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Times New Roman"/>
                        </a:rPr>
                        <a:t>PLAU</a:t>
                      </a:r>
                      <a:endParaRPr lang="en-US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Times New Roman"/>
                        </a:rPr>
                        <a:t>1.0</a:t>
                      </a:r>
                      <a:endParaRPr lang="en-US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Times New Roman"/>
                        </a:rPr>
                        <a:t>1.1</a:t>
                      </a:r>
                      <a:endParaRPr lang="en-US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Times New Roman"/>
                        </a:rPr>
                        <a:t>1.7</a:t>
                      </a:r>
                      <a:endParaRPr lang="en-US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Times New Roman"/>
                        </a:rPr>
                        <a:t>2.1</a:t>
                      </a:r>
                      <a:endParaRPr lang="en-US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9654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Times New Roman"/>
                        </a:rPr>
                        <a:t>EpCAM</a:t>
                      </a:r>
                      <a:endParaRPr lang="en-US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Times New Roman"/>
                        </a:rPr>
                        <a:t>EPCAM (TACSTD1)</a:t>
                      </a:r>
                      <a:endParaRPr lang="en-US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Times New Roman"/>
                        </a:rPr>
                        <a:t>1.0</a:t>
                      </a:r>
                      <a:endParaRPr lang="en-US" sz="1200" dirty="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Times New Roman"/>
                        </a:rPr>
                        <a:t>1.8</a:t>
                      </a:r>
                      <a:endParaRPr lang="en-US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Times New Roman"/>
                        </a:rPr>
                        <a:t>2.4</a:t>
                      </a:r>
                      <a:endParaRPr lang="en-US" sz="1200" dirty="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Times New Roman"/>
                        </a:rPr>
                        <a:t>3.2</a:t>
                      </a:r>
                      <a:endParaRPr lang="en-US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6225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Times New Roman"/>
                        </a:rPr>
                        <a:t>Integrin β4</a:t>
                      </a:r>
                      <a:endParaRPr lang="en-US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Times New Roman"/>
                        </a:rPr>
                        <a:t>ITGB4</a:t>
                      </a:r>
                      <a:endParaRPr lang="en-US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Times New Roman"/>
                        </a:rPr>
                        <a:t>1.0</a:t>
                      </a:r>
                      <a:endParaRPr lang="en-US" sz="1200" dirty="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Times New Roman"/>
                        </a:rPr>
                        <a:t>8.8</a:t>
                      </a:r>
                      <a:endParaRPr lang="en-US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Times New Roman"/>
                        </a:rPr>
                        <a:t>16.0</a:t>
                      </a:r>
                      <a:endParaRPr lang="en-US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Times New Roman"/>
                        </a:rPr>
                        <a:t>18.6</a:t>
                      </a:r>
                      <a:endParaRPr lang="en-US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 rowSpan="3">
                  <a:txBody>
                    <a:bodyPr/>
                    <a:lstStyle/>
                    <a:p>
                      <a:pPr marL="71755" marR="71755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</a:rPr>
                        <a:t>Housekeeping genes</a:t>
                      </a:r>
                      <a:endParaRPr lang="en-US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 vert="vert27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</a:rPr>
                        <a:t>60S ribosomal protein L11</a:t>
                      </a:r>
                      <a:endParaRPr lang="en-US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Times New Roman"/>
                        </a:rPr>
                        <a:t>RPL11</a:t>
                      </a:r>
                      <a:endParaRPr lang="en-US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Times New Roman"/>
                        </a:rPr>
                        <a:t>1.0</a:t>
                      </a:r>
                      <a:endParaRPr lang="en-US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Times New Roman"/>
                        </a:rPr>
                        <a:t>0.9</a:t>
                      </a:r>
                      <a:endParaRPr lang="en-US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Times New Roman"/>
                        </a:rPr>
                        <a:t>1.0</a:t>
                      </a:r>
                      <a:endParaRPr lang="en-US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Times New Roman"/>
                        </a:rPr>
                        <a:t>1.0</a:t>
                      </a:r>
                      <a:endParaRPr lang="en-US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</a:rPr>
                        <a:t>NADH dehydrogenase (ubiquinone) 1 α subcomplex</a:t>
                      </a:r>
                      <a:endParaRPr lang="en-US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Times New Roman"/>
                        </a:rPr>
                        <a:t>NFUFA1</a:t>
                      </a:r>
                      <a:endParaRPr lang="en-US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Times New Roman"/>
                        </a:rPr>
                        <a:t>1.0</a:t>
                      </a:r>
                      <a:endParaRPr lang="en-US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Times New Roman"/>
                        </a:rPr>
                        <a:t>1.0</a:t>
                      </a:r>
                      <a:endParaRPr lang="en-US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Times New Roman"/>
                        </a:rPr>
                        <a:t>1.0</a:t>
                      </a:r>
                      <a:endParaRPr lang="en-US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Times New Roman"/>
                        </a:rPr>
                        <a:t>0.9</a:t>
                      </a:r>
                      <a:endParaRPr lang="en-US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</a:rPr>
                        <a:t>ATPase, H+ transporting, lysosomal 13kDa, V1 subunit G1</a:t>
                      </a:r>
                      <a:endParaRPr lang="en-US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Times New Roman"/>
                        </a:rPr>
                        <a:t>ATP6V1G1</a:t>
                      </a:r>
                      <a:endParaRPr lang="en-US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Times New Roman"/>
                        </a:rPr>
                        <a:t>1.0</a:t>
                      </a:r>
                      <a:endParaRPr lang="en-US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Times New Roman"/>
                        </a:rPr>
                        <a:t>1.1</a:t>
                      </a:r>
                      <a:endParaRPr lang="en-US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Times New Roman"/>
                        </a:rPr>
                        <a:t>1.1</a:t>
                      </a:r>
                      <a:endParaRPr lang="en-US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Times New Roman"/>
                        </a:rPr>
                        <a:t>1.1</a:t>
                      </a:r>
                      <a:endParaRPr lang="en-US" sz="1200" dirty="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5459099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64</TotalTime>
  <Words>142</Words>
  <Application>Microsoft Macintosh PowerPoint</Application>
  <PresentationFormat>On-screen Show (4:3)</PresentationFormat>
  <Paragraphs>60</Paragraphs>
  <Slides>2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PowerPoint Presentation</vt:lpstr>
      <vt:lpstr>PowerPoint Presentation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anyard, Jacqueline</dc:creator>
  <cp:lastModifiedBy>Diane Bielenberg</cp:lastModifiedBy>
  <cp:revision>5</cp:revision>
  <dcterms:created xsi:type="dcterms:W3CDTF">2013-09-12T18:49:43Z</dcterms:created>
  <dcterms:modified xsi:type="dcterms:W3CDTF">2014-03-26T18:24:27Z</dcterms:modified>
</cp:coreProperties>
</file>